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10"/>
  </p:notesMasterIdLst>
  <p:sldIdLst>
    <p:sldId id="258" r:id="rId2"/>
    <p:sldId id="265" r:id="rId3"/>
    <p:sldId id="262" r:id="rId4"/>
    <p:sldId id="259" r:id="rId5"/>
    <p:sldId id="266" r:id="rId6"/>
    <p:sldId id="263" r:id="rId7"/>
    <p:sldId id="260" r:id="rId8"/>
    <p:sldId id="261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31" autoAdjust="0"/>
    <p:restoredTop sz="92042" autoAdjust="0"/>
  </p:normalViewPr>
  <p:slideViewPr>
    <p:cSldViewPr snapToGrid="0">
      <p:cViewPr varScale="1">
        <p:scale>
          <a:sx n="83" d="100"/>
          <a:sy n="83" d="100"/>
        </p:scale>
        <p:origin x="-3120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D5DCBE-D8ED-43CD-A31D-D82904C3C4D5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084062-3750-44DB-885F-C223EFBC120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168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70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084062-3750-44DB-885F-C223EFBC120E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4515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4145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191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1675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5585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7612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55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3453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1883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6456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88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7222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588B53-C9F9-4369-B62D-63ED68C11938}" type="datetimeFigureOut">
              <a:rPr lang="zh-CN" altLang="en-US" smtClean="0"/>
              <a:pPr/>
              <a:t>2019/4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4C9922-3B33-4D15-BAF4-CFC3B33605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7627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gif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gif"/><Relationship Id="rId2" Type="http://schemas.openxmlformats.org/officeDocument/2006/relationships/image" Target="../media/image7.gi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16632" y="179512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260180" y="717333"/>
            <a:ext cx="6227357" cy="4908360"/>
            <a:chOff x="260180" y="717333"/>
            <a:chExt cx="6227357" cy="490836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268" y="717333"/>
              <a:ext cx="2920055" cy="1439464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6395" y="2433008"/>
              <a:ext cx="2921142" cy="1440000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180" y="2433008"/>
              <a:ext cx="2921143" cy="1440000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180" y="4185693"/>
              <a:ext cx="2921143" cy="14400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6394" y="717333"/>
              <a:ext cx="2921143" cy="1440000"/>
            </a:xfrm>
            <a:prstGeom prst="rect">
              <a:avLst/>
            </a:prstGeom>
          </p:spPr>
        </p:pic>
      </p:grpSp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EA81EE89-53F1-42A2-9EBA-A22BE612875E}"/>
              </a:ext>
            </a:extLst>
          </p:cNvPr>
          <p:cNvSpPr/>
          <p:nvPr/>
        </p:nvSpPr>
        <p:spPr>
          <a:xfrm>
            <a:off x="260180" y="5938378"/>
            <a:ext cx="6134372" cy="4388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800" b="1" kern="100" dirty="0">
                <a:solidFill>
                  <a:srgbClr val="000000"/>
                </a:solidFill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Figure S1 The predicted membrane topology of FROs in Rice and Arabidopsis. 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ea typeface="仿宋" panose="02010609060101010101" pitchFamily="49" charset="-122"/>
                <a:cs typeface="Arial" panose="020B0604020202020204" pitchFamily="34" charset="0"/>
              </a:rPr>
              <a:t>Red line indicates the transmembrane part of proteins, blue line indicates the inner part of  membrane of proteins and pink line indicate the outer part of membrane of proteins. </a:t>
            </a:r>
            <a:endParaRPr lang="zh-CN" altLang="zh-CN" sz="8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44990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矩形 29">
            <a:extLst>
              <a:ext uri="{FF2B5EF4-FFF2-40B4-BE49-F238E27FC236}">
                <a16:creationId xmlns:a16="http://schemas.microsoft.com/office/drawing/2014/main" xmlns="" id="{FB1A9E94-218C-4DA7-8EF2-CDB757572C74}"/>
              </a:ext>
            </a:extLst>
          </p:cNvPr>
          <p:cNvSpPr/>
          <p:nvPr/>
        </p:nvSpPr>
        <p:spPr>
          <a:xfrm>
            <a:off x="435134" y="5187637"/>
            <a:ext cx="622145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Subcellular localization of OsFRO1.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A) OsFRO1-GFP expression. (B) The tonoplast marker,OsSPX-MFS3. (C) Bright ﬁeld image. (D) Overlay image of the three channels. Bars = 20 </a:t>
            </a:r>
            <a:r>
              <a:rPr lang="el-GR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EF3C7C55-6184-4542-B0A8-FBF097A97EC8}"/>
              </a:ext>
            </a:extLst>
          </p:cNvPr>
          <p:cNvSpPr/>
          <p:nvPr/>
        </p:nvSpPr>
        <p:spPr>
          <a:xfrm>
            <a:off x="0" y="0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6236" y="504479"/>
            <a:ext cx="4395597" cy="45480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1476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3"/>
          <p:cNvSpPr txBox="1"/>
          <p:nvPr/>
        </p:nvSpPr>
        <p:spPr>
          <a:xfrm>
            <a:off x="149870" y="243845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xmlns="" id="{DE47EE26-C9BC-4863-8B0B-9ACB471AADDC}"/>
              </a:ext>
            </a:extLst>
          </p:cNvPr>
          <p:cNvSpPr/>
          <p:nvPr/>
        </p:nvSpPr>
        <p:spPr>
          <a:xfrm>
            <a:off x="656692" y="8097554"/>
            <a:ext cx="5544616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800"/>
              </a:lnSpc>
              <a:spcAft>
                <a:spcPts val="0"/>
              </a:spcAft>
            </a:pPr>
            <a:r>
              <a:rPr lang="en-US" altLang="zh-CN" sz="1000" b="1" kern="10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Figure </a:t>
            </a:r>
            <a:r>
              <a:rPr lang="en-US" altLang="zh-CN" sz="1000" b="1" kern="100" dirty="0" smtClean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S3. </a:t>
            </a:r>
            <a:r>
              <a:rPr lang="en-US" altLang="zh-CN" sz="1000" b="1" kern="10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Expression levels of </a:t>
            </a:r>
            <a:r>
              <a:rPr lang="en-US" altLang="zh-CN" sz="1000" b="1" i="1" kern="10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OsFRO1 </a:t>
            </a:r>
            <a:r>
              <a:rPr lang="en-US" altLang="zh-CN" sz="1000" b="1" kern="100" dirty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in different tissues (A) and different development stages (B) based on microarray data retrieved from GENEVESTIGATOR (https://genevestigator.com/gv/).</a:t>
            </a:r>
            <a:endParaRPr lang="zh-CN" altLang="en-US" sz="1000" b="1" kern="100" dirty="0">
              <a:latin typeface="Times New Roman" panose="02020603050405020304" pitchFamily="18" charset="0"/>
              <a:ea typeface="仿宋" panose="02010609060101010101" pitchFamily="49" charset="-122"/>
              <a:cs typeface="Times New Roman" panose="02020603050405020304" pitchFamily="18" charset="0"/>
            </a:endParaRPr>
          </a:p>
          <a:p>
            <a:pPr algn="just">
              <a:lnSpc>
                <a:spcPts val="1800"/>
              </a:lnSpc>
              <a:spcAft>
                <a:spcPts val="0"/>
              </a:spcAft>
            </a:pPr>
            <a:endParaRPr lang="zh-CN" altLang="zh-CN" sz="10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xmlns="" id="{FD48620A-ED0E-4CB9-BF18-E4BBF1E577B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184" b="3035"/>
          <a:stretch/>
        </p:blipFill>
        <p:spPr>
          <a:xfrm>
            <a:off x="1630362" y="3890699"/>
            <a:ext cx="3597275" cy="420685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xmlns="" id="{1272DA90-B186-4AC5-9A1B-B3A2B3E841B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76" r="4167" b="1366"/>
          <a:stretch/>
        </p:blipFill>
        <p:spPr>
          <a:xfrm>
            <a:off x="2130250" y="505455"/>
            <a:ext cx="2821633" cy="3169225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xmlns="" id="{31A26178-D618-4848-8317-E9FFCA45CD90}"/>
              </a:ext>
            </a:extLst>
          </p:cNvPr>
          <p:cNvSpPr txBox="1"/>
          <p:nvPr/>
        </p:nvSpPr>
        <p:spPr>
          <a:xfrm>
            <a:off x="1408519" y="523845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xmlns="" id="{487C9E21-E523-4CE8-85B4-84ED3543DAD4}"/>
              </a:ext>
            </a:extLst>
          </p:cNvPr>
          <p:cNvSpPr txBox="1"/>
          <p:nvPr/>
        </p:nvSpPr>
        <p:spPr>
          <a:xfrm>
            <a:off x="1398349" y="3909089"/>
            <a:ext cx="7920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46733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16632" y="179512"/>
            <a:ext cx="14401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F82F1E2E-9794-4335-BFA1-B621AB2593D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078" y="843778"/>
            <a:ext cx="3851148" cy="2402354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xmlns="" id="{67D1A979-CF97-4B6E-81EB-AA79CA7F4E02}"/>
              </a:ext>
            </a:extLst>
          </p:cNvPr>
          <p:cNvSpPr/>
          <p:nvPr/>
        </p:nvSpPr>
        <p:spPr>
          <a:xfrm>
            <a:off x="455712" y="3539342"/>
            <a:ext cx="555629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800" b="1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800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4 </a:t>
            </a:r>
            <a:r>
              <a:rPr lang="en-US" altLang="zh-CN" sz="800" b="1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dentification of </a:t>
            </a:r>
            <a:r>
              <a:rPr lang="en-US" altLang="zh-CN" sz="800" b="1" i="1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FRO1 </a:t>
            </a:r>
            <a:r>
              <a:rPr lang="en-US" altLang="zh-CN" sz="800" b="1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verexpression and RNAi lines.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NA was extracted from the leaves of three-week-old seedlings. All data are means of three biological replicates with error bars indicating SD. Expression of </a:t>
            </a:r>
            <a:r>
              <a:rPr lang="en-US" altLang="zh-CN" sz="800" i="1" kern="1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sACTIN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as used as the control.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igniﬁcance of differences compared to WT is indicated by asterisks (Tukey’s test; *P&lt;0.05).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zh-CN" altLang="zh-CN" sz="8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114550" y="1342208"/>
            <a:ext cx="469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*</a:t>
            </a:r>
            <a:endParaRPr lang="zh-CN" altLang="en-US" sz="1100" dirty="0"/>
          </a:p>
        </p:txBody>
      </p:sp>
      <p:sp>
        <p:nvSpPr>
          <p:cNvPr id="7" name="文本框 6"/>
          <p:cNvSpPr txBox="1"/>
          <p:nvPr/>
        </p:nvSpPr>
        <p:spPr>
          <a:xfrm>
            <a:off x="2508250" y="1096168"/>
            <a:ext cx="469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*</a:t>
            </a:r>
            <a:endParaRPr lang="zh-CN" altLang="en-US" sz="1100" dirty="0"/>
          </a:p>
        </p:txBody>
      </p:sp>
      <p:sp>
        <p:nvSpPr>
          <p:cNvPr id="8" name="文本框 1"/>
          <p:cNvSpPr txBox="1"/>
          <p:nvPr/>
        </p:nvSpPr>
        <p:spPr>
          <a:xfrm>
            <a:off x="2895600" y="1682216"/>
            <a:ext cx="469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</a:t>
            </a:r>
            <a:endParaRPr lang="zh-CN" altLang="en-US" sz="1100" dirty="0"/>
          </a:p>
        </p:txBody>
      </p:sp>
      <p:sp>
        <p:nvSpPr>
          <p:cNvPr id="9" name="文本框 1"/>
          <p:cNvSpPr txBox="1"/>
          <p:nvPr/>
        </p:nvSpPr>
        <p:spPr>
          <a:xfrm>
            <a:off x="4070350" y="2567945"/>
            <a:ext cx="469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</a:t>
            </a:r>
            <a:endParaRPr lang="zh-CN" altLang="en-US" sz="1100" dirty="0"/>
          </a:p>
        </p:txBody>
      </p:sp>
      <p:sp>
        <p:nvSpPr>
          <p:cNvPr id="10" name="文本框 1"/>
          <p:cNvSpPr txBox="1"/>
          <p:nvPr/>
        </p:nvSpPr>
        <p:spPr>
          <a:xfrm>
            <a:off x="3284659" y="2352419"/>
            <a:ext cx="469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</a:t>
            </a:r>
            <a:endParaRPr lang="zh-CN" altLang="en-US" sz="1100" dirty="0"/>
          </a:p>
        </p:txBody>
      </p:sp>
      <p:sp>
        <p:nvSpPr>
          <p:cNvPr id="11" name="文本框 1"/>
          <p:cNvSpPr txBox="1"/>
          <p:nvPr/>
        </p:nvSpPr>
        <p:spPr>
          <a:xfrm>
            <a:off x="3677505" y="2363475"/>
            <a:ext cx="4699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/>
              <a:t>*</a:t>
            </a:r>
            <a:endParaRPr lang="zh-CN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2880470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矩形 18">
            <a:extLst>
              <a:ext uri="{FF2B5EF4-FFF2-40B4-BE49-F238E27FC236}">
                <a16:creationId xmlns:a16="http://schemas.microsoft.com/office/drawing/2014/main" xmlns="" id="{EF3C7C55-6184-4542-B0A8-FBF097A97EC8}"/>
              </a:ext>
            </a:extLst>
          </p:cNvPr>
          <p:cNvSpPr/>
          <p:nvPr/>
        </p:nvSpPr>
        <p:spPr>
          <a:xfrm>
            <a:off x="0" y="0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528639" y="8447729"/>
            <a:ext cx="604887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rowth performance of  WT and transgenic plants.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hree-week-old seedlings were transferred to nutrient solutions containing 0.125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or 0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 Fe (II)-EDTA and 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rown for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ays.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(A) Growth performance of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plants with or without Fe supply. (B) Shoot and root length of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plants with or without Fe supply. (C) Analysis of Fe concentration in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Ri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plants by ICP-OES. Data are shown as the mean and standard deviation (n=3).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xmlns="" id="{69283387-1555-4019-8314-DAEA6FC62672}"/>
              </a:ext>
            </a:extLst>
          </p:cNvPr>
          <p:cNvSpPr txBox="1"/>
          <p:nvPr/>
        </p:nvSpPr>
        <p:spPr>
          <a:xfrm>
            <a:off x="223302" y="447572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xmlns="" id="{69283387-1555-4019-8314-DAEA6FC62672}"/>
              </a:ext>
            </a:extLst>
          </p:cNvPr>
          <p:cNvSpPr txBox="1"/>
          <p:nvPr/>
        </p:nvSpPr>
        <p:spPr>
          <a:xfrm>
            <a:off x="223302" y="2817083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3">
            <a:extLst>
              <a:ext uri="{FF2B5EF4-FFF2-40B4-BE49-F238E27FC236}">
                <a16:creationId xmlns:a16="http://schemas.microsoft.com/office/drawing/2014/main" xmlns="" id="{69283387-1555-4019-8314-DAEA6FC62672}"/>
              </a:ext>
            </a:extLst>
          </p:cNvPr>
          <p:cNvSpPr txBox="1"/>
          <p:nvPr/>
        </p:nvSpPr>
        <p:spPr>
          <a:xfrm>
            <a:off x="223302" y="5345659"/>
            <a:ext cx="419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2402" y="586071"/>
            <a:ext cx="6047756" cy="7754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3840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0" y="0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xmlns="" id="{CEE17D68-1ECF-4B4A-AE61-EAB0F1C0BFFC}"/>
              </a:ext>
            </a:extLst>
          </p:cNvPr>
          <p:cNvSpPr/>
          <p:nvPr/>
        </p:nvSpPr>
        <p:spPr>
          <a:xfrm>
            <a:off x="593387" y="6198115"/>
            <a:ext cx="583482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nalysis of Cu, Zn, Mn concentrations in WT and transgenic plants.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wo-week-old plants were grown on nutrient solution supplied with 0.125 mM or 7 mM Fe (II)-EDTA for 3 days. Metal concentrations in leaves and roots were measured by ICP-OES. Data are shown as the mean and standard deviation (n=3). 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D37B3758-9F54-44C1-8265-A5E996C5936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028" y="452815"/>
            <a:ext cx="6177188" cy="5661817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16632" y="179512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CA29131A-F5AD-423A-8507-343D2D9A41AF}"/>
              </a:ext>
            </a:extLst>
          </p:cNvPr>
          <p:cNvSpPr/>
          <p:nvPr/>
        </p:nvSpPr>
        <p:spPr>
          <a:xfrm>
            <a:off x="263103" y="3876486"/>
            <a:ext cx="633179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 </a:t>
            </a:r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Fe(III) chelate reductase assay in yeast cells. 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Yeast strain with empty vector is used as a negative control and with AtFRO2 gene vector as a  positive control. Data are shown as the </a:t>
            </a:r>
            <a:r>
              <a:rPr lang="en-US" altLang="zh-CN" sz="800" dirty="0" err="1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 (n=3). Signiﬁcance of differences compared to the control (Empty-Vector) is indicated by asterisks (Tukey’s test; **P&lt;0.01).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1083684" y="640702"/>
            <a:ext cx="3733976" cy="3051592"/>
            <a:chOff x="1083684" y="640702"/>
            <a:chExt cx="3733976" cy="3051592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3684" y="640702"/>
              <a:ext cx="3733976" cy="3051592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2756997" y="1346200"/>
              <a:ext cx="412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*</a:t>
              </a:r>
              <a:r>
                <a:rPr lang="zh-CN" altLang="en-US" sz="1400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4955700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3">
            <a:extLst>
              <a:ext uri="{FF2B5EF4-FFF2-40B4-BE49-F238E27FC236}">
                <a16:creationId xmlns:a16="http://schemas.microsoft.com/office/drawing/2014/main" xmlns="" id="{10C1F9E9-11EC-47C4-A92F-BD22733B8E92}"/>
              </a:ext>
            </a:extLst>
          </p:cNvPr>
          <p:cNvSpPr txBox="1"/>
          <p:nvPr/>
        </p:nvSpPr>
        <p:spPr>
          <a:xfrm>
            <a:off x="149870" y="243845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xmlns="" id="{A2EC7986-1D5A-499D-B0B3-CB7EE6AA72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340998"/>
              </p:ext>
            </p:extLst>
          </p:nvPr>
        </p:nvGraphicFramePr>
        <p:xfrm>
          <a:off x="697704" y="707230"/>
          <a:ext cx="4636295" cy="575040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49459">
                  <a:extLst>
                    <a:ext uri="{9D8B030D-6E8A-4147-A177-3AD203B41FA5}">
                      <a16:colId xmlns:a16="http://schemas.microsoft.com/office/drawing/2014/main" xmlns="" val="3256591774"/>
                    </a:ext>
                  </a:extLst>
                </a:gridCol>
                <a:gridCol w="3186836">
                  <a:extLst>
                    <a:ext uri="{9D8B030D-6E8A-4147-A177-3AD203B41FA5}">
                      <a16:colId xmlns:a16="http://schemas.microsoft.com/office/drawing/2014/main" xmlns="" val="492660297"/>
                    </a:ext>
                  </a:extLst>
                </a:gridCol>
              </a:tblGrid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rpos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-3’)</a:t>
                      </a:r>
                      <a:endParaRPr lang="zh-CN" altLang="zh-CN" sz="1000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91494926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bcellar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ocalization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17106139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-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GFP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CATGACGCCATCCATGATGG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724017721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GFP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GGTCGAAGCTGTGGCT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486977268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expression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037696042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OE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CATGACGCCATCCATGATG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714884359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OE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GGTCGAAGCTGTGGCTG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28560780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moter: GUS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298445143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r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TCTAGATGTTGCTCCCTAGCTGCGATC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913004059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Pr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TACCGGCGAGCGGCTGTGAACGGTA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337906252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A  interferenc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902764851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FRO1-Ri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ACAAGTTTGTACAAAAAAGCAGGCTTCGGGC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TGAATCGCCATACCAC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7699913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FRO1-Ri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ACCACTTTGTACAAGAAAGCTGGGTCGGATCMGTCATCCCCAACAATGCCT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27589417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ast expression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917767128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L1-OsFRO1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TACCATGACGCCATCCATGATGG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036470875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L1-OsFRO1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TCTAGACTACAGGTCGAAGCTGTGGCT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859905818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L1-AtFRO2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GGGTACCATGGAGATCGAAAAAAGCAATAACG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398208546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L1-AtFRO2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CTCTAGATCACCAGCTGAAACTGATAGAT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708620120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qRT</a:t>
                      </a: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-PC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610744258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ACACCCCTGCTATGTAC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549443119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</a:t>
                      </a:r>
                      <a:r>
                        <a:rPr lang="en-US" sz="1000" kern="1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TCACCAGAGTCCAACACAA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862741572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F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CGACGCGCAGTTCATCAG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091576331"/>
                  </a:ext>
                </a:extLst>
              </a:tr>
              <a:tr h="24480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FRO1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  <a:r>
                        <a:rPr lang="en-US" sz="10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R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000" kern="100" dirty="0"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AACATGCCGGTCGCCTTCT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021" marR="12021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1038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0187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72</TotalTime>
  <Words>480</Words>
  <Application>Microsoft Office PowerPoint</Application>
  <PresentationFormat>全屏显示(4:3)</PresentationFormat>
  <Paragraphs>72</Paragraphs>
  <Slides>8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9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DELL</cp:lastModifiedBy>
  <cp:revision>79</cp:revision>
  <dcterms:created xsi:type="dcterms:W3CDTF">2019-01-31T02:44:37Z</dcterms:created>
  <dcterms:modified xsi:type="dcterms:W3CDTF">2019-04-25T08:50:43Z</dcterms:modified>
</cp:coreProperties>
</file>